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2" r:id="rId2"/>
    <p:sldId id="303" r:id="rId3"/>
    <p:sldId id="304" r:id="rId4"/>
    <p:sldId id="305" r:id="rId5"/>
    <p:sldId id="306" r:id="rId6"/>
    <p:sldId id="307" r:id="rId7"/>
    <p:sldId id="308" r:id="rId8"/>
    <p:sldId id="309" r:id="rId9"/>
    <p:sldId id="310" r:id="rId10"/>
    <p:sldId id="311" r:id="rId11"/>
    <p:sldId id="312" r:id="rId12"/>
    <p:sldId id="313" r:id="rId13"/>
    <p:sldId id="314" r:id="rId14"/>
    <p:sldId id="289" r:id="rId15"/>
    <p:sldId id="290" r:id="rId16"/>
    <p:sldId id="291" r:id="rId17"/>
    <p:sldId id="292" r:id="rId18"/>
    <p:sldId id="293" r:id="rId19"/>
    <p:sldId id="294" r:id="rId20"/>
    <p:sldId id="295" r:id="rId21"/>
    <p:sldId id="296" r:id="rId22"/>
    <p:sldId id="300" r:id="rId23"/>
    <p:sldId id="297" r:id="rId24"/>
    <p:sldId id="298" r:id="rId25"/>
    <p:sldId id="299" r:id="rId26"/>
    <p:sldId id="301" r:id="rId2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230" autoAdjust="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688" y="-288"/>
      </p:cViewPr>
      <p:guideLst>
        <p:guide orient="horz" pos="2880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printerSettings" Target="printerSettings/printerSettings1.bin"/><Relationship Id="rId29" Type="http://schemas.openxmlformats.org/officeDocument/2006/relationships/presProps" Target="presProps.xml"/><Relationship Id="rId30" Type="http://schemas.openxmlformats.org/officeDocument/2006/relationships/viewProps" Target="viewProps.xml"/><Relationship Id="rId31" Type="http://schemas.openxmlformats.org/officeDocument/2006/relationships/theme" Target="theme/theme1.xml"/><Relationship Id="rId32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33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76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7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77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10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596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98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707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139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298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54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2A837-15F8-AE42-B5E3-2F8960AA057C}" type="datetimeFigureOut">
              <a:rPr lang="en-US" smtClean="0"/>
              <a:t>1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B7456-0B88-0740-BEC7-F15B0315A3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238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e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5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7.emf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9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0.emf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1.emf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2.emf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3.emf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4.emf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emf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6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 - IL-1a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A. IL-1α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65824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0 - IL-1RA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J. IL-1RA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4894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1 - IL-12p40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K. IL-12p40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77993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2 - IL-13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442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L. IL-13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67489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3 - IL-10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M. IL-10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44335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 - IL-1a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N. IL-1α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39704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 - IL-1b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O. IL-1β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956716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3 - IL-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P. IL-2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10606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4 - IL-6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Q. IL-6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05364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5 - IL-8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R. IL-8 normalized to PGK1</a:t>
            </a:r>
            <a:r>
              <a:rPr lang="en-US" dirty="0"/>
              <a:t>.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8726372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6 - IL-4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S. IL-4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21359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 - IL-1b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B. IL-1β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947730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 - IFN-g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8673"/>
            <a:ext cx="6858000" cy="824665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T. IFN-</a:t>
            </a:r>
            <a:r>
              <a:rPr lang="en-US" dirty="0" err="1" smtClean="0"/>
              <a:t>γ</a:t>
            </a:r>
            <a:r>
              <a:rPr lang="en-US" dirty="0" smtClean="0"/>
              <a:t>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758236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8 - TNF-a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U. TNF-α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076034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2 - IL-18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V. IL-18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51189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 - IL-1RA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W. IL-1RA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519111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0 - IL-12p40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X. IL-12p40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62383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1 - IL-13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Y. IL-13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49999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3 - IL-10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6945"/>
            <a:ext cx="6858000" cy="82101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Z. IL-10 normalized to PGK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3522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3 - IL-2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C. IL-2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8864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4 - IL-6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D. IL-6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046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5 - IL-8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E. IL-8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6047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6 - IL-4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F. IL-4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89308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 - IFNg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G. IFN-</a:t>
            </a:r>
            <a:r>
              <a:rPr lang="en-US" dirty="0" err="1" smtClean="0"/>
              <a:t>γ</a:t>
            </a:r>
            <a:r>
              <a:rPr lang="en-US" dirty="0" smtClean="0"/>
              <a:t>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46481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8 - TNFa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H. TNF-α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00499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 - IL-18 All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30"/>
            <a:ext cx="6858000" cy="767413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183" y="31591"/>
            <a:ext cx="586407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Figure I. IL-18 normalized to RPS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1764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</TotalTime>
  <Words>260</Words>
  <Application>Microsoft Macintosh PowerPoint</Application>
  <PresentationFormat>On-screen Show (4:3)</PresentationFormat>
  <Paragraphs>26</Paragraphs>
  <Slides>2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2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RS/US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elia Hofstetter</dc:creator>
  <cp:lastModifiedBy>Amelia Hofstetter</cp:lastModifiedBy>
  <cp:revision>12</cp:revision>
  <dcterms:created xsi:type="dcterms:W3CDTF">2017-10-20T18:15:27Z</dcterms:created>
  <dcterms:modified xsi:type="dcterms:W3CDTF">2017-11-02T19:57:34Z</dcterms:modified>
</cp:coreProperties>
</file>